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4572000" cy="15541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67" autoAdjust="0"/>
    <p:restoredTop sz="94660"/>
  </p:normalViewPr>
  <p:slideViewPr>
    <p:cSldViewPr snapToGrid="0">
      <p:cViewPr varScale="1">
        <p:scale>
          <a:sx n="183" d="100"/>
          <a:sy n="183" d="100"/>
        </p:scale>
        <p:origin x="144" y="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Manuscript\Media_hornome_result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Manuscript\Media_hornome_result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Manuscript\Media_hornome_result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Manuscript\Media_hornome_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513.A</a:t>
            </a:r>
          </a:p>
        </c:rich>
      </c:tx>
      <c:layout>
        <c:manualLayout>
          <c:xMode val="edge"/>
          <c:yMode val="edge"/>
          <c:x val="0.39456433004960628"/>
          <c:y val="1.809784193642461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617429070928122"/>
          <c:y val="0.27069626713327505"/>
          <c:w val="0.63576010925132154"/>
          <c:h val="0.573640918852085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1.6860835943894242E-2"/>
                  <c:y val="2.4793822259820804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136%</a:t>
                    </a:r>
                  </a:p>
                  <a:p>
                    <a:r>
                      <a:rPr lang="en-US" b="1" dirty="0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0455733355911152"/>
                      <c:h val="0.2129476584022038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7AD4-4FCC-AB22-B8E6E91C1BE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2!$D$11:$E$11</c:f>
                <c:numCache>
                  <c:formatCode>General</c:formatCode>
                  <c:ptCount val="2"/>
                  <c:pt idx="0">
                    <c:v>0.2672612419124244</c:v>
                  </c:pt>
                  <c:pt idx="1">
                    <c:v>0.31622776601683855</c:v>
                  </c:pt>
                </c:numCache>
              </c:numRef>
            </c:plus>
            <c:minus>
              <c:numRef>
                <c:f>Sheet2!$D$11:$E$11</c:f>
                <c:numCache>
                  <c:formatCode>General</c:formatCode>
                  <c:ptCount val="2"/>
                  <c:pt idx="0">
                    <c:v>0.2672612419124244</c:v>
                  </c:pt>
                  <c:pt idx="1">
                    <c:v>0.3162277660168385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5:$E$5</c:f>
              <c:strCache>
                <c:ptCount val="2"/>
                <c:pt idx="0">
                  <c:v>No trim</c:v>
                </c:pt>
                <c:pt idx="1">
                  <c:v>Trim</c:v>
                </c:pt>
              </c:strCache>
            </c:strRef>
          </c:cat>
          <c:val>
            <c:numRef>
              <c:f>Sheet2!$D$6:$E$6</c:f>
              <c:numCache>
                <c:formatCode>0.0</c:formatCode>
                <c:ptCount val="2"/>
                <c:pt idx="0">
                  <c:v>5</c:v>
                </c:pt>
                <c:pt idx="1">
                  <c:v>6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D4-4FCC-AB22-B8E6E91C1B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465094552"/>
        <c:axId val="465095208"/>
      </c:barChart>
      <c:catAx>
        <c:axId val="465094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5208"/>
        <c:crosses val="autoZero"/>
        <c:auto val="1"/>
        <c:lblAlgn val="ctr"/>
        <c:lblOffset val="100"/>
        <c:noMultiLvlLbl val="0"/>
      </c:catAx>
      <c:valAx>
        <c:axId val="465095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Shoot number</a:t>
                </a:r>
              </a:p>
            </c:rich>
          </c:tx>
          <c:layout>
            <c:manualLayout>
              <c:xMode val="edge"/>
              <c:yMode val="edge"/>
              <c:x val="1.759376852087037E-3"/>
              <c:y val="0.277511984555649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4552"/>
        <c:crosses val="autoZero"/>
        <c:crossBetween val="between"/>
        <c:majorUnit val="2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250.A</a:t>
            </a:r>
          </a:p>
        </c:rich>
      </c:tx>
      <c:layout>
        <c:manualLayout>
          <c:xMode val="edge"/>
          <c:yMode val="edge"/>
          <c:x val="0.3390361575008342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1220603707027256"/>
          <c:y val="0.26147718377308099"/>
          <c:w val="0.67148482222978623"/>
          <c:h val="0.5966924529170695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1.0471108463220684E-2"/>
                  <c:y val="-1.7543475767654391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141%</a:t>
                    </a:r>
                  </a:p>
                  <a:p>
                    <a:r>
                      <a:rPr lang="en-US" b="1" dirty="0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455818085170896"/>
                      <c:h val="0.255262816372602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FA06-4FBE-8B63-AA868BBD8AD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2!$D$12:$E$12</c:f>
                <c:numCache>
                  <c:formatCode>General</c:formatCode>
                  <c:ptCount val="2"/>
                  <c:pt idx="0">
                    <c:v>0.20203050891044178</c:v>
                  </c:pt>
                  <c:pt idx="1">
                    <c:v>0.69006555934235425</c:v>
                  </c:pt>
                </c:numCache>
              </c:numRef>
            </c:plus>
            <c:minus>
              <c:numRef>
                <c:f>Sheet2!$D$12:$E$12</c:f>
                <c:numCache>
                  <c:formatCode>General</c:formatCode>
                  <c:ptCount val="2"/>
                  <c:pt idx="0">
                    <c:v>0.20203050891044178</c:v>
                  </c:pt>
                  <c:pt idx="1">
                    <c:v>0.6900655593423542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5:$E$5</c:f>
              <c:strCache>
                <c:ptCount val="2"/>
                <c:pt idx="0">
                  <c:v>No trim</c:v>
                </c:pt>
                <c:pt idx="1">
                  <c:v>Trim</c:v>
                </c:pt>
              </c:strCache>
            </c:strRef>
          </c:cat>
          <c:val>
            <c:numRef>
              <c:f>Sheet2!$D$7:$E$7</c:f>
              <c:numCache>
                <c:formatCode>0.0</c:formatCode>
                <c:ptCount val="2"/>
                <c:pt idx="0">
                  <c:v>3.4285714285714284</c:v>
                </c:pt>
                <c:pt idx="1">
                  <c:v>4.8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06-4FBE-8B63-AA868BBD8A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465094552"/>
        <c:axId val="465095208"/>
      </c:barChart>
      <c:catAx>
        <c:axId val="465094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5208"/>
        <c:crosses val="autoZero"/>
        <c:auto val="1"/>
        <c:lblAlgn val="ctr"/>
        <c:lblOffset val="100"/>
        <c:noMultiLvlLbl val="0"/>
      </c:catAx>
      <c:valAx>
        <c:axId val="465095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Shoot number</a:t>
                </a:r>
              </a:p>
            </c:rich>
          </c:tx>
          <c:layout>
            <c:manualLayout>
              <c:xMode val="edge"/>
              <c:yMode val="edge"/>
              <c:x val="2.5973172014729091E-3"/>
              <c:y val="0.264194890955953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4552"/>
        <c:crosses val="autoZero"/>
        <c:crossBetween val="between"/>
        <c:majorUnit val="2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250.B</a:t>
            </a:r>
          </a:p>
        </c:rich>
      </c:tx>
      <c:layout>
        <c:manualLayout>
          <c:xMode val="edge"/>
          <c:yMode val="edge"/>
          <c:x val="0.3918792938293403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339526398980192"/>
          <c:y val="0.22690246096084313"/>
          <c:w val="0.69000804361426404"/>
          <c:h val="0.607221866756807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1.0561148891823432E-2"/>
                  <c:y val="-1.514936589664811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118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702538705134002"/>
                      <c:h val="0.2129648632497721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3CB3-4E04-925D-09F9A371FBD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2!$D$13:$E$13</c:f>
                <c:numCache>
                  <c:formatCode>General</c:formatCode>
                  <c:ptCount val="2"/>
                  <c:pt idx="0">
                    <c:v>0.50709255283710997</c:v>
                  </c:pt>
                  <c:pt idx="1">
                    <c:v>0</c:v>
                  </c:pt>
                </c:numCache>
              </c:numRef>
            </c:plus>
            <c:minus>
              <c:numRef>
                <c:f>Sheet2!$D$13:$E$13</c:f>
                <c:numCache>
                  <c:formatCode>General</c:formatCode>
                  <c:ptCount val="2"/>
                  <c:pt idx="0">
                    <c:v>0.50709255283710997</c:v>
                  </c:pt>
                  <c:pt idx="1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5:$E$5</c:f>
              <c:strCache>
                <c:ptCount val="2"/>
                <c:pt idx="0">
                  <c:v>No trim</c:v>
                </c:pt>
                <c:pt idx="1">
                  <c:v>Trim</c:v>
                </c:pt>
              </c:strCache>
            </c:strRef>
          </c:cat>
          <c:val>
            <c:numRef>
              <c:f>Sheet2!$D$8:$E$8</c:f>
              <c:numCache>
                <c:formatCode>0.0</c:formatCode>
                <c:ptCount val="2"/>
                <c:pt idx="0">
                  <c:v>3.4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B3-4E04-925D-09F9A371FB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465094552"/>
        <c:axId val="465095208"/>
      </c:barChart>
      <c:catAx>
        <c:axId val="465094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5208"/>
        <c:crosses val="autoZero"/>
        <c:auto val="1"/>
        <c:lblAlgn val="ctr"/>
        <c:lblOffset val="100"/>
        <c:noMultiLvlLbl val="0"/>
      </c:catAx>
      <c:valAx>
        <c:axId val="46509520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Shoot number</a:t>
                </a:r>
              </a:p>
            </c:rich>
          </c:tx>
          <c:layout>
            <c:manualLayout>
              <c:xMode val="edge"/>
              <c:yMode val="edge"/>
              <c:x val="6.227254495070395E-5"/>
              <c:y val="0.252376093047073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4552"/>
        <c:crosses val="autoZero"/>
        <c:crossBetween val="between"/>
        <c:majorUnit val="2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216.A</a:t>
            </a:r>
          </a:p>
        </c:rich>
      </c:tx>
      <c:layout>
        <c:manualLayout>
          <c:xMode val="edge"/>
          <c:yMode val="edge"/>
          <c:x val="0.3726109751706265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1380364340963907"/>
          <c:y val="0.22410794593848757"/>
          <c:w val="0.67890674379988214"/>
          <c:h val="0.6019860399546126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6.8029591536960411E-3"/>
                  <c:y val="2.7128522634956402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125%</a:t>
                    </a:r>
                  </a:p>
                  <a:p>
                    <a:r>
                      <a:rPr lang="en-US" b="1" dirty="0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1670643578170488"/>
                      <c:h val="0.2446256136226628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3BA5-438D-B5B6-F9748460E7C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2!$D$14:$E$14</c:f>
                <c:numCache>
                  <c:formatCode>General</c:formatCode>
                  <c:ptCount val="2"/>
                  <c:pt idx="0">
                    <c:v>0.21081851067789217</c:v>
                  </c:pt>
                  <c:pt idx="1">
                    <c:v>0.21081851067789159</c:v>
                  </c:pt>
                </c:numCache>
              </c:numRef>
            </c:plus>
            <c:minus>
              <c:numRef>
                <c:f>Sheet2!$D$14:$E$14</c:f>
                <c:numCache>
                  <c:formatCode>General</c:formatCode>
                  <c:ptCount val="2"/>
                  <c:pt idx="0">
                    <c:v>0.21081851067789217</c:v>
                  </c:pt>
                  <c:pt idx="1">
                    <c:v>0.2108185106778915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D$5:$E$5</c:f>
              <c:strCache>
                <c:ptCount val="2"/>
                <c:pt idx="0">
                  <c:v>No trim</c:v>
                </c:pt>
                <c:pt idx="1">
                  <c:v>Trim</c:v>
                </c:pt>
              </c:strCache>
            </c:strRef>
          </c:cat>
          <c:val>
            <c:numRef>
              <c:f>Sheet2!$D$9:$E$9</c:f>
              <c:numCache>
                <c:formatCode>0.0</c:formatCode>
                <c:ptCount val="2"/>
                <c:pt idx="0">
                  <c:v>2.6666666666666665</c:v>
                </c:pt>
                <c:pt idx="1">
                  <c:v>3.33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A5-438D-B5B6-F9748460E7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465094552"/>
        <c:axId val="465095208"/>
      </c:barChart>
      <c:catAx>
        <c:axId val="465094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5208"/>
        <c:crosses val="autoZero"/>
        <c:auto val="1"/>
        <c:lblAlgn val="ctr"/>
        <c:lblOffset val="100"/>
        <c:noMultiLvlLbl val="0"/>
      </c:catAx>
      <c:valAx>
        <c:axId val="465095208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Shoot number</a:t>
                </a:r>
              </a:p>
            </c:rich>
          </c:tx>
          <c:layout>
            <c:manualLayout>
              <c:xMode val="edge"/>
              <c:yMode val="edge"/>
              <c:x val="3.0390937974858408E-4"/>
              <c:y val="0.23541626002032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094552"/>
        <c:crosses val="autoZero"/>
        <c:crossBetween val="between"/>
        <c:majorUnit val="1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71500" y="254350"/>
            <a:ext cx="3429000" cy="541079"/>
          </a:xfrm>
        </p:spPr>
        <p:txBody>
          <a:bodyPr anchor="b"/>
          <a:lstStyle>
            <a:lvl1pPr algn="ctr">
              <a:defRPr sz="1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816295"/>
            <a:ext cx="3429000" cy="375230"/>
          </a:xfrm>
        </p:spPr>
        <p:txBody>
          <a:bodyPr/>
          <a:lstStyle>
            <a:lvl1pPr marL="0" indent="0" algn="ctr">
              <a:buNone/>
              <a:defRPr sz="544"/>
            </a:lvl1pPr>
            <a:lvl2pPr marL="103602" indent="0" algn="ctr">
              <a:buNone/>
              <a:defRPr sz="453"/>
            </a:lvl2pPr>
            <a:lvl3pPr marL="207203" indent="0" algn="ctr">
              <a:buNone/>
              <a:defRPr sz="408"/>
            </a:lvl3pPr>
            <a:lvl4pPr marL="310805" indent="0" algn="ctr">
              <a:buNone/>
              <a:defRPr sz="363"/>
            </a:lvl4pPr>
            <a:lvl5pPr marL="414406" indent="0" algn="ctr">
              <a:buNone/>
              <a:defRPr sz="363"/>
            </a:lvl5pPr>
            <a:lvl6pPr marL="518008" indent="0" algn="ctr">
              <a:buNone/>
              <a:defRPr sz="363"/>
            </a:lvl6pPr>
            <a:lvl7pPr marL="621609" indent="0" algn="ctr">
              <a:buNone/>
              <a:defRPr sz="363"/>
            </a:lvl7pPr>
            <a:lvl8pPr marL="725211" indent="0" algn="ctr">
              <a:buNone/>
              <a:defRPr sz="363"/>
            </a:lvl8pPr>
            <a:lvl9pPr marL="828812" indent="0" algn="ctr">
              <a:buNone/>
              <a:defRPr sz="36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489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14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7" y="82745"/>
            <a:ext cx="985838" cy="131708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82745"/>
            <a:ext cx="2900363" cy="1317081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384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850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387461"/>
            <a:ext cx="3943350" cy="646489"/>
          </a:xfrm>
        </p:spPr>
        <p:txBody>
          <a:bodyPr anchor="b"/>
          <a:lstStyle>
            <a:lvl1pPr>
              <a:defRPr sz="1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1040066"/>
            <a:ext cx="3943350" cy="339973"/>
          </a:xfrm>
        </p:spPr>
        <p:txBody>
          <a:bodyPr/>
          <a:lstStyle>
            <a:lvl1pPr marL="0" indent="0">
              <a:buNone/>
              <a:defRPr sz="544">
                <a:solidFill>
                  <a:schemeClr val="tx1">
                    <a:tint val="75000"/>
                  </a:schemeClr>
                </a:solidFill>
              </a:defRPr>
            </a:lvl1pPr>
            <a:lvl2pPr marL="103602" indent="0">
              <a:buNone/>
              <a:defRPr sz="453">
                <a:solidFill>
                  <a:schemeClr val="tx1">
                    <a:tint val="75000"/>
                  </a:schemeClr>
                </a:solidFill>
              </a:defRPr>
            </a:lvl2pPr>
            <a:lvl3pPr marL="207203" indent="0">
              <a:buNone/>
              <a:defRPr sz="408">
                <a:solidFill>
                  <a:schemeClr val="tx1">
                    <a:tint val="75000"/>
                  </a:schemeClr>
                </a:solidFill>
              </a:defRPr>
            </a:lvl3pPr>
            <a:lvl4pPr marL="310805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4pPr>
            <a:lvl5pPr marL="414406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5pPr>
            <a:lvl6pPr marL="518008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6pPr>
            <a:lvl7pPr marL="621609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7pPr>
            <a:lvl8pPr marL="725211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8pPr>
            <a:lvl9pPr marL="828812" indent="0">
              <a:buNone/>
              <a:defRPr sz="3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924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413724"/>
            <a:ext cx="1943100" cy="98610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413724"/>
            <a:ext cx="1943100" cy="98610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908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82745"/>
            <a:ext cx="3943350" cy="3004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380986"/>
            <a:ext cx="1934170" cy="186715"/>
          </a:xfrm>
        </p:spPr>
        <p:txBody>
          <a:bodyPr anchor="b"/>
          <a:lstStyle>
            <a:lvl1pPr marL="0" indent="0">
              <a:buNone/>
              <a:defRPr sz="544" b="1"/>
            </a:lvl1pPr>
            <a:lvl2pPr marL="103602" indent="0">
              <a:buNone/>
              <a:defRPr sz="453" b="1"/>
            </a:lvl2pPr>
            <a:lvl3pPr marL="207203" indent="0">
              <a:buNone/>
              <a:defRPr sz="408" b="1"/>
            </a:lvl3pPr>
            <a:lvl4pPr marL="310805" indent="0">
              <a:buNone/>
              <a:defRPr sz="363" b="1"/>
            </a:lvl4pPr>
            <a:lvl5pPr marL="414406" indent="0">
              <a:buNone/>
              <a:defRPr sz="363" b="1"/>
            </a:lvl5pPr>
            <a:lvl6pPr marL="518008" indent="0">
              <a:buNone/>
              <a:defRPr sz="363" b="1"/>
            </a:lvl6pPr>
            <a:lvl7pPr marL="621609" indent="0">
              <a:buNone/>
              <a:defRPr sz="363" b="1"/>
            </a:lvl7pPr>
            <a:lvl8pPr marL="725211" indent="0">
              <a:buNone/>
              <a:defRPr sz="363" b="1"/>
            </a:lvl8pPr>
            <a:lvl9pPr marL="828812" indent="0">
              <a:buNone/>
              <a:defRPr sz="36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567701"/>
            <a:ext cx="1934170" cy="83500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380986"/>
            <a:ext cx="1943696" cy="186715"/>
          </a:xfrm>
        </p:spPr>
        <p:txBody>
          <a:bodyPr anchor="b"/>
          <a:lstStyle>
            <a:lvl1pPr marL="0" indent="0">
              <a:buNone/>
              <a:defRPr sz="544" b="1"/>
            </a:lvl1pPr>
            <a:lvl2pPr marL="103602" indent="0">
              <a:buNone/>
              <a:defRPr sz="453" b="1"/>
            </a:lvl2pPr>
            <a:lvl3pPr marL="207203" indent="0">
              <a:buNone/>
              <a:defRPr sz="408" b="1"/>
            </a:lvl3pPr>
            <a:lvl4pPr marL="310805" indent="0">
              <a:buNone/>
              <a:defRPr sz="363" b="1"/>
            </a:lvl4pPr>
            <a:lvl5pPr marL="414406" indent="0">
              <a:buNone/>
              <a:defRPr sz="363" b="1"/>
            </a:lvl5pPr>
            <a:lvl6pPr marL="518008" indent="0">
              <a:buNone/>
              <a:defRPr sz="363" b="1"/>
            </a:lvl6pPr>
            <a:lvl7pPr marL="621609" indent="0">
              <a:buNone/>
              <a:defRPr sz="363" b="1"/>
            </a:lvl7pPr>
            <a:lvl8pPr marL="725211" indent="0">
              <a:buNone/>
              <a:defRPr sz="363" b="1"/>
            </a:lvl8pPr>
            <a:lvl9pPr marL="828812" indent="0">
              <a:buNone/>
              <a:defRPr sz="36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567701"/>
            <a:ext cx="1943696" cy="83500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257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25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013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103611"/>
            <a:ext cx="1474589" cy="362638"/>
          </a:xfrm>
        </p:spPr>
        <p:txBody>
          <a:bodyPr anchor="b"/>
          <a:lstStyle>
            <a:lvl1pPr>
              <a:defRPr sz="72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223771"/>
            <a:ext cx="2314575" cy="1104463"/>
          </a:xfrm>
        </p:spPr>
        <p:txBody>
          <a:bodyPr/>
          <a:lstStyle>
            <a:lvl1pPr>
              <a:defRPr sz="725"/>
            </a:lvl1pPr>
            <a:lvl2pPr>
              <a:defRPr sz="634"/>
            </a:lvl2pPr>
            <a:lvl3pPr>
              <a:defRPr sz="544"/>
            </a:lvl3pPr>
            <a:lvl4pPr>
              <a:defRPr sz="453"/>
            </a:lvl4pPr>
            <a:lvl5pPr>
              <a:defRPr sz="453"/>
            </a:lvl5pPr>
            <a:lvl6pPr>
              <a:defRPr sz="453"/>
            </a:lvl6pPr>
            <a:lvl7pPr>
              <a:defRPr sz="453"/>
            </a:lvl7pPr>
            <a:lvl8pPr>
              <a:defRPr sz="453"/>
            </a:lvl8pPr>
            <a:lvl9pPr>
              <a:defRPr sz="453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466249"/>
            <a:ext cx="1474589" cy="863784"/>
          </a:xfrm>
        </p:spPr>
        <p:txBody>
          <a:bodyPr/>
          <a:lstStyle>
            <a:lvl1pPr marL="0" indent="0">
              <a:buNone/>
              <a:defRPr sz="363"/>
            </a:lvl1pPr>
            <a:lvl2pPr marL="103602" indent="0">
              <a:buNone/>
              <a:defRPr sz="317"/>
            </a:lvl2pPr>
            <a:lvl3pPr marL="207203" indent="0">
              <a:buNone/>
              <a:defRPr sz="272"/>
            </a:lvl3pPr>
            <a:lvl4pPr marL="310805" indent="0">
              <a:buNone/>
              <a:defRPr sz="227"/>
            </a:lvl4pPr>
            <a:lvl5pPr marL="414406" indent="0">
              <a:buNone/>
              <a:defRPr sz="227"/>
            </a:lvl5pPr>
            <a:lvl6pPr marL="518008" indent="0">
              <a:buNone/>
              <a:defRPr sz="227"/>
            </a:lvl6pPr>
            <a:lvl7pPr marL="621609" indent="0">
              <a:buNone/>
              <a:defRPr sz="227"/>
            </a:lvl7pPr>
            <a:lvl8pPr marL="725211" indent="0">
              <a:buNone/>
              <a:defRPr sz="227"/>
            </a:lvl8pPr>
            <a:lvl9pPr marL="828812" indent="0">
              <a:buNone/>
              <a:defRPr sz="2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008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103611"/>
            <a:ext cx="1474589" cy="362638"/>
          </a:xfrm>
        </p:spPr>
        <p:txBody>
          <a:bodyPr anchor="b"/>
          <a:lstStyle>
            <a:lvl1pPr>
              <a:defRPr sz="72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223771"/>
            <a:ext cx="2314575" cy="1104463"/>
          </a:xfrm>
        </p:spPr>
        <p:txBody>
          <a:bodyPr anchor="t"/>
          <a:lstStyle>
            <a:lvl1pPr marL="0" indent="0">
              <a:buNone/>
              <a:defRPr sz="725"/>
            </a:lvl1pPr>
            <a:lvl2pPr marL="103602" indent="0">
              <a:buNone/>
              <a:defRPr sz="634"/>
            </a:lvl2pPr>
            <a:lvl3pPr marL="207203" indent="0">
              <a:buNone/>
              <a:defRPr sz="544"/>
            </a:lvl3pPr>
            <a:lvl4pPr marL="310805" indent="0">
              <a:buNone/>
              <a:defRPr sz="453"/>
            </a:lvl4pPr>
            <a:lvl5pPr marL="414406" indent="0">
              <a:buNone/>
              <a:defRPr sz="453"/>
            </a:lvl5pPr>
            <a:lvl6pPr marL="518008" indent="0">
              <a:buNone/>
              <a:defRPr sz="453"/>
            </a:lvl6pPr>
            <a:lvl7pPr marL="621609" indent="0">
              <a:buNone/>
              <a:defRPr sz="453"/>
            </a:lvl7pPr>
            <a:lvl8pPr marL="725211" indent="0">
              <a:buNone/>
              <a:defRPr sz="453"/>
            </a:lvl8pPr>
            <a:lvl9pPr marL="828812" indent="0">
              <a:buNone/>
              <a:defRPr sz="45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466249"/>
            <a:ext cx="1474589" cy="863784"/>
          </a:xfrm>
        </p:spPr>
        <p:txBody>
          <a:bodyPr/>
          <a:lstStyle>
            <a:lvl1pPr marL="0" indent="0">
              <a:buNone/>
              <a:defRPr sz="363"/>
            </a:lvl1pPr>
            <a:lvl2pPr marL="103602" indent="0">
              <a:buNone/>
              <a:defRPr sz="317"/>
            </a:lvl2pPr>
            <a:lvl3pPr marL="207203" indent="0">
              <a:buNone/>
              <a:defRPr sz="272"/>
            </a:lvl3pPr>
            <a:lvl4pPr marL="310805" indent="0">
              <a:buNone/>
              <a:defRPr sz="227"/>
            </a:lvl4pPr>
            <a:lvl5pPr marL="414406" indent="0">
              <a:buNone/>
              <a:defRPr sz="227"/>
            </a:lvl5pPr>
            <a:lvl6pPr marL="518008" indent="0">
              <a:buNone/>
              <a:defRPr sz="227"/>
            </a:lvl6pPr>
            <a:lvl7pPr marL="621609" indent="0">
              <a:buNone/>
              <a:defRPr sz="227"/>
            </a:lvl7pPr>
            <a:lvl8pPr marL="725211" indent="0">
              <a:buNone/>
              <a:defRPr sz="227"/>
            </a:lvl8pPr>
            <a:lvl9pPr marL="828812" indent="0">
              <a:buNone/>
              <a:defRPr sz="2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882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82745"/>
            <a:ext cx="3943350" cy="300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413724"/>
            <a:ext cx="3943350" cy="98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1440479"/>
            <a:ext cx="1028700" cy="827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E84AFB-D540-471F-96F1-CC69BD64545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1440479"/>
            <a:ext cx="1543050" cy="827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1440479"/>
            <a:ext cx="1028700" cy="827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9415B-2925-486E-BFD6-73F044636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789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207203" rtl="0" eaLnBrk="1" latinLnBrk="0" hangingPunct="1">
        <a:lnSpc>
          <a:spcPct val="90000"/>
        </a:lnSpc>
        <a:spcBef>
          <a:spcPct val="0"/>
        </a:spcBef>
        <a:buNone/>
        <a:defRPr sz="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1801" indent="-51801" algn="l" defTabSz="207203" rtl="0" eaLnBrk="1" latinLnBrk="0" hangingPunct="1">
        <a:lnSpc>
          <a:spcPct val="90000"/>
        </a:lnSpc>
        <a:spcBef>
          <a:spcPts val="227"/>
        </a:spcBef>
        <a:buFont typeface="Arial" panose="020B0604020202020204" pitchFamily="34" charset="0"/>
        <a:buChar char="•"/>
        <a:defRPr sz="634" kern="1200">
          <a:solidFill>
            <a:schemeClr val="tx1"/>
          </a:solidFill>
          <a:latin typeface="+mn-lt"/>
          <a:ea typeface="+mn-ea"/>
          <a:cs typeface="+mn-cs"/>
        </a:defRPr>
      </a:lvl1pPr>
      <a:lvl2pPr marL="155402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544" kern="1200">
          <a:solidFill>
            <a:schemeClr val="tx1"/>
          </a:solidFill>
          <a:latin typeface="+mn-lt"/>
          <a:ea typeface="+mn-ea"/>
          <a:cs typeface="+mn-cs"/>
        </a:defRPr>
      </a:lvl2pPr>
      <a:lvl3pPr marL="259004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53" kern="1200">
          <a:solidFill>
            <a:schemeClr val="tx1"/>
          </a:solidFill>
          <a:latin typeface="+mn-lt"/>
          <a:ea typeface="+mn-ea"/>
          <a:cs typeface="+mn-cs"/>
        </a:defRPr>
      </a:lvl3pPr>
      <a:lvl4pPr marL="362605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4pPr>
      <a:lvl5pPr marL="466207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5pPr>
      <a:lvl6pPr marL="569808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6pPr>
      <a:lvl7pPr marL="673410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7pPr>
      <a:lvl8pPr marL="777011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8pPr>
      <a:lvl9pPr marL="880613" indent="-51801" algn="l" defTabSz="207203" rtl="0" eaLnBrk="1" latinLnBrk="0" hangingPunct="1">
        <a:lnSpc>
          <a:spcPct val="90000"/>
        </a:lnSpc>
        <a:spcBef>
          <a:spcPts val="113"/>
        </a:spcBef>
        <a:buFont typeface="Arial" panose="020B0604020202020204" pitchFamily="34" charset="0"/>
        <a:buChar char="•"/>
        <a:defRPr sz="4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1pPr>
      <a:lvl2pPr marL="103602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2pPr>
      <a:lvl3pPr marL="207203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3pPr>
      <a:lvl4pPr marL="310805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4pPr>
      <a:lvl5pPr marL="414406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5pPr>
      <a:lvl6pPr marL="518008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6pPr>
      <a:lvl7pPr marL="621609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7pPr>
      <a:lvl8pPr marL="725211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8pPr>
      <a:lvl9pPr marL="828812" algn="l" defTabSz="207203" rtl="0" eaLnBrk="1" latinLnBrk="0" hangingPunct="1">
        <a:defRPr sz="4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7029" y="74295"/>
            <a:ext cx="4467229" cy="1396095"/>
            <a:chOff x="1699" y="-5443"/>
            <a:chExt cx="4467229" cy="1396095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73889899"/>
                </p:ext>
              </p:extLst>
            </p:nvPr>
          </p:nvGraphicFramePr>
          <p:xfrm>
            <a:off x="1699" y="-5443"/>
            <a:ext cx="1055914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4170935"/>
                </p:ext>
              </p:extLst>
            </p:nvPr>
          </p:nvGraphicFramePr>
          <p:xfrm>
            <a:off x="1104898" y="16329"/>
            <a:ext cx="1034144" cy="13253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29181084"/>
                </p:ext>
              </p:extLst>
            </p:nvPr>
          </p:nvGraphicFramePr>
          <p:xfrm>
            <a:off x="2233612" y="21772"/>
            <a:ext cx="1059317" cy="13552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0958850"/>
                </p:ext>
              </p:extLst>
            </p:nvPr>
          </p:nvGraphicFramePr>
          <p:xfrm>
            <a:off x="3383077" y="16330"/>
            <a:ext cx="1085851" cy="13743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549703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23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oble Foundai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Yong Qin</dc:creator>
  <cp:lastModifiedBy>Wang, Yong Qin</cp:lastModifiedBy>
  <cp:revision>10</cp:revision>
  <dcterms:created xsi:type="dcterms:W3CDTF">2020-11-21T05:09:14Z</dcterms:created>
  <dcterms:modified xsi:type="dcterms:W3CDTF">2021-02-06T03:00:01Z</dcterms:modified>
</cp:coreProperties>
</file>